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wmf" ContentType="image/x-wmf"/>
  <Override PartName="/ppt/media/image8.jpeg" ContentType="image/jpeg"/>
  <Override PartName="/ppt/media/image10.jpeg" ContentType="image/jpeg"/>
  <Override PartName="/ppt/media/image9.jpeg" ContentType="image/jpeg"/>
  <Override PartName="/ppt/media/image11.jpeg" ContentType="image/jpeg"/>
  <Override PartName="/ppt/media/image12.jpeg" ContentType="image/jpeg"/>
  <Override PartName="/ppt/media/image7.jpeg" ContentType="image/jpeg"/>
  <Override PartName="/ppt/media/image20.jpeg" ContentType="image/jpeg"/>
  <Override PartName="/ppt/media/image19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.jpeg" ContentType="image/jpeg"/>
  <Override PartName="/ppt/media/image15.wmf" ContentType="image/x-wmf"/>
  <Override PartName="/ppt/media/image14.wmf" ContentType="image/x-wmf"/>
  <Override PartName="/ppt/media/image5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6.jpeg" ContentType="image/jpe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28619450" cy="299910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04A164-1947-4543-ACA5-A3FFF10A47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966680" y="7983360"/>
            <a:ext cx="246870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966680" y="17924040"/>
            <a:ext cx="246870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F2EEB0-40F1-4289-AC29-05D48F176B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966680" y="798336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4616360" y="798336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966680" y="1792404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4616360" y="1792404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2D4E3-94F5-496C-AB45-652FEE45DA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966680" y="7983360"/>
            <a:ext cx="79488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0313280" y="7983360"/>
            <a:ext cx="79488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8659880" y="7983360"/>
            <a:ext cx="79488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966680" y="17924040"/>
            <a:ext cx="79488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0313280" y="17924040"/>
            <a:ext cx="79488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8659880" y="17924040"/>
            <a:ext cx="79488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0EF8F-CB5A-4988-AA31-A2BC47D8E3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966680" y="7983360"/>
            <a:ext cx="24687000" cy="19031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3124"/>
              </a:spcBef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3286D-699B-48EF-BE3F-6986C9499E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966680" y="7983360"/>
            <a:ext cx="24687000" cy="1903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9B79F-44BD-4EF2-9BB5-D7EF4A4082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966680" y="7983360"/>
            <a:ext cx="12047040" cy="1903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4616360" y="7983360"/>
            <a:ext cx="12047040" cy="1903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F9ED1-EABD-4F9D-AAFE-C79FC0A2BC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19493-1FA4-44C6-9A6A-4E12D8B499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966680" y="1596960"/>
            <a:ext cx="24687000" cy="26874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3124"/>
              </a:spcBef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F5673-EFA4-4789-A556-48C3203EE4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966680" y="798336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4616360" y="7983360"/>
            <a:ext cx="12047040" cy="1903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966680" y="1792404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B2187-FA60-40B1-81C0-465BFC975E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966680" y="7983360"/>
            <a:ext cx="12047040" cy="1903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4616360" y="798336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4616360" y="1792404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9FE7E-1B2E-4880-AA6D-CCEF8941AC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966680" y="798336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4616360" y="7983360"/>
            <a:ext cx="1204704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966680" y="17924040"/>
            <a:ext cx="24687000" cy="9077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3124"/>
              </a:spcBef>
              <a:buNone/>
              <a:tabLst>
                <a:tab algn="l" pos="2860560"/>
                <a:tab algn="l" pos="5721480"/>
                <a:tab algn="l" pos="8582040"/>
              </a:tabLst>
            </a:pP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6D3F78-9A5F-4C97-9014-6A4A7CBDA0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966680" y="1596960"/>
            <a:ext cx="24687000" cy="5797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2860560"/>
                <a:tab algn="l" pos="5721480"/>
                <a:tab algn="l" pos="8582040"/>
              </a:tabLst>
            </a:pPr>
            <a:r>
              <a:rPr b="0" lang="en-US" sz="137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1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966680" y="7983360"/>
            <a:ext cx="24687000" cy="19031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714240" indent="-714240">
              <a:lnSpc>
                <a:spcPct val="90000"/>
              </a:lnSpc>
              <a:spcBef>
                <a:spcPts val="3124"/>
              </a:spcBef>
              <a:buClr>
                <a:srgbClr val="000000"/>
              </a:buClr>
              <a:buFont typeface="Arial"/>
              <a:buChar char="•"/>
              <a:tabLst>
                <a:tab algn="l" pos="2860560"/>
                <a:tab algn="l" pos="5721480"/>
                <a:tab algn="l" pos="8582040"/>
              </a:tabLst>
            </a:pPr>
            <a:r>
              <a:rPr b="0" lang="en-US" sz="8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  <a:p>
            <a:pPr lvl="1" marL="2146320" indent="-714240">
              <a:lnSpc>
                <a:spcPct val="90000"/>
              </a:lnSpc>
              <a:spcBef>
                <a:spcPts val="3124"/>
              </a:spcBef>
              <a:buClr>
                <a:srgbClr val="000000"/>
              </a:buClr>
              <a:buFont typeface="Arial"/>
              <a:buChar char="•"/>
              <a:tabLst>
                <a:tab algn="l" pos="2860560"/>
                <a:tab algn="l" pos="5721480"/>
                <a:tab algn="l" pos="8582040"/>
              </a:tabLst>
            </a:pPr>
            <a:r>
              <a:rPr b="0" lang="en-US" sz="8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  <a:p>
            <a:pPr lvl="2" marL="3576600" indent="-714240">
              <a:lnSpc>
                <a:spcPct val="90000"/>
              </a:lnSpc>
              <a:spcBef>
                <a:spcPts val="3124"/>
              </a:spcBef>
              <a:buClr>
                <a:srgbClr val="000000"/>
              </a:buClr>
              <a:buFont typeface="Arial"/>
              <a:buChar char="•"/>
              <a:tabLst>
                <a:tab algn="l" pos="2860560"/>
                <a:tab algn="l" pos="5721480"/>
                <a:tab algn="l" pos="8582040"/>
              </a:tabLst>
            </a:pPr>
            <a:r>
              <a:rPr b="0" lang="en-US" sz="8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  <a:p>
            <a:pPr lvl="3" marL="5008680" indent="-714600">
              <a:lnSpc>
                <a:spcPct val="90000"/>
              </a:lnSpc>
              <a:spcBef>
                <a:spcPts val="3124"/>
              </a:spcBef>
              <a:buClr>
                <a:srgbClr val="000000"/>
              </a:buClr>
              <a:buFont typeface="Arial"/>
              <a:buChar char="•"/>
              <a:tabLst>
                <a:tab algn="l" pos="2860560"/>
                <a:tab algn="l" pos="5721480"/>
                <a:tab algn="l" pos="8582040"/>
              </a:tabLst>
            </a:pPr>
            <a:r>
              <a:rPr b="0" lang="en-US" sz="8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  <a:p>
            <a:pPr lvl="4" marL="6438960" indent="-714600">
              <a:lnSpc>
                <a:spcPct val="90000"/>
              </a:lnSpc>
              <a:spcBef>
                <a:spcPts val="3124"/>
              </a:spcBef>
              <a:buClr>
                <a:srgbClr val="000000"/>
              </a:buClr>
              <a:buFont typeface="Arial"/>
              <a:buChar char="•"/>
              <a:tabLst>
                <a:tab algn="l" pos="2860560"/>
                <a:tab algn="l" pos="5721480"/>
                <a:tab algn="l" pos="8582040"/>
              </a:tabLst>
            </a:pPr>
            <a:r>
              <a:rPr b="0" lang="en-US" sz="8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  <a:p>
            <a:pPr lvl="5" marL="6438960" indent="-714600">
              <a:lnSpc>
                <a:spcPct val="90000"/>
              </a:lnSpc>
              <a:spcBef>
                <a:spcPts val="3124"/>
              </a:spcBef>
              <a:buClr>
                <a:srgbClr val="000000"/>
              </a:buClr>
              <a:buFont typeface="Arial"/>
              <a:buChar char="•"/>
              <a:tabLst>
                <a:tab algn="l" pos="2860560"/>
                <a:tab algn="l" pos="5721480"/>
                <a:tab algn="l" pos="8582040"/>
              </a:tabLst>
            </a:pPr>
            <a:r>
              <a:rPr b="0" lang="en-US" sz="8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  <a:p>
            <a:pPr lvl="6" marL="6438960" indent="-714600">
              <a:lnSpc>
                <a:spcPct val="90000"/>
              </a:lnSpc>
              <a:spcBef>
                <a:spcPts val="3124"/>
              </a:spcBef>
              <a:buClr>
                <a:srgbClr val="000000"/>
              </a:buClr>
              <a:buFont typeface="Arial"/>
              <a:buChar char="•"/>
              <a:tabLst>
                <a:tab algn="l" pos="2860560"/>
                <a:tab algn="l" pos="5721480"/>
                <a:tab algn="l" pos="8582040"/>
              </a:tabLst>
            </a:pPr>
            <a:r>
              <a:rPr b="0" lang="en-US" sz="8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8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967040" y="27798840"/>
            <a:ext cx="6440400" cy="1596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9480240" y="27798840"/>
            <a:ext cx="9659880" cy="1596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0213640" y="27798840"/>
            <a:ext cx="6440400" cy="1596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3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D700042-B67D-47E4-8BA2-EFDA44DBDFFC}" type="slidenum">
              <a:rPr b="0" lang="en-US" sz="3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4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5.wmf"/><Relationship Id="rId7" Type="http://schemas.openxmlformats.org/officeDocument/2006/relationships/image" Target="../media/image16.jpeg"/><Relationship Id="rId8" Type="http://schemas.openxmlformats.org/officeDocument/2006/relationships/image" Target="../media/image17.jpeg"/><Relationship Id="rId9" Type="http://schemas.openxmlformats.org/officeDocument/2006/relationships/image" Target="../media/image18.jpeg"/><Relationship Id="rId10" Type="http://schemas.openxmlformats.org/officeDocument/2006/relationships/image" Target="../media/image19.jpeg"/><Relationship Id="rId11" Type="http://schemas.openxmlformats.org/officeDocument/2006/relationships/image" Target="../media/image20.jpeg"/><Relationship Id="rId1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852480" y="189000"/>
            <a:ext cx="26717760" cy="7047000"/>
            <a:chOff x="852480" y="189000"/>
            <a:chExt cx="26717760" cy="7047000"/>
          </a:xfrm>
        </p:grpSpPr>
        <p:pic>
          <p:nvPicPr>
            <p:cNvPr id="42" name="Picture 2" descr=""/>
            <p:cNvPicPr/>
            <p:nvPr/>
          </p:nvPicPr>
          <p:blipFill>
            <a:blip r:embed="rId1"/>
            <a:stretch/>
          </p:blipFill>
          <p:spPr>
            <a:xfrm>
              <a:off x="1600200" y="1019880"/>
              <a:ext cx="8290440" cy="62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7" descr="A picture containing text&#10;&#10;Description automatically generated"/>
            <p:cNvPicPr/>
            <p:nvPr/>
          </p:nvPicPr>
          <p:blipFill>
            <a:blip r:embed="rId2"/>
            <a:stretch/>
          </p:blipFill>
          <p:spPr>
            <a:xfrm>
              <a:off x="10440000" y="1019880"/>
              <a:ext cx="8290440" cy="6216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9" descr="Map&#10;&#10;Description automatically generated"/>
            <p:cNvPicPr/>
            <p:nvPr/>
          </p:nvPicPr>
          <p:blipFill>
            <a:blip r:embed="rId3"/>
            <a:stretch/>
          </p:blipFill>
          <p:spPr>
            <a:xfrm>
              <a:off x="19279800" y="970560"/>
              <a:ext cx="8290440" cy="6217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Box 2"/>
            <p:cNvSpPr/>
            <p:nvPr/>
          </p:nvSpPr>
          <p:spPr>
            <a:xfrm>
              <a:off x="852480" y="970560"/>
              <a:ext cx="1280160" cy="100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6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4"/>
            <p:cNvSpPr/>
            <p:nvPr/>
          </p:nvSpPr>
          <p:spPr>
            <a:xfrm>
              <a:off x="3796920" y="189720"/>
              <a:ext cx="3276720" cy="82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1C1iPSC</a:t>
              </a:r>
              <a:endParaRPr b="0" lang="en-US" sz="4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5"/>
            <p:cNvSpPr/>
            <p:nvPr/>
          </p:nvSpPr>
          <p:spPr>
            <a:xfrm>
              <a:off x="12261240" y="281160"/>
              <a:ext cx="4633920" cy="82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P2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等线"/>
                </a:rPr>
                <a:t>-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C8iPSCs</a:t>
              </a:r>
              <a:endParaRPr b="0" lang="en-US" sz="4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6"/>
            <p:cNvSpPr/>
            <p:nvPr/>
          </p:nvSpPr>
          <p:spPr>
            <a:xfrm>
              <a:off x="20944080" y="189000"/>
              <a:ext cx="4961880" cy="82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P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等线"/>
                </a:rPr>
                <a:t>3-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C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等线"/>
                </a:rPr>
                <a:t>6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iPSCs</a:t>
              </a:r>
              <a:endParaRPr b="0" lang="en-US" sz="4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9" name="Group 19"/>
          <p:cNvGrpSpPr/>
          <p:nvPr/>
        </p:nvGrpSpPr>
        <p:grpSpPr>
          <a:xfrm>
            <a:off x="719280" y="7493040"/>
            <a:ext cx="26849160" cy="12764880"/>
            <a:chOff x="719280" y="7493040"/>
            <a:chExt cx="26849160" cy="12764880"/>
          </a:xfrm>
        </p:grpSpPr>
        <p:pic>
          <p:nvPicPr>
            <p:cNvPr id="50" name="Picture 2" descr="A picture containing broccoli, vegetable&#10;&#10;Description automatically generated"/>
            <p:cNvPicPr/>
            <p:nvPr/>
          </p:nvPicPr>
          <p:blipFill>
            <a:blip r:embed="rId4"/>
            <a:stretch/>
          </p:blipFill>
          <p:spPr>
            <a:xfrm>
              <a:off x="1594440" y="7518960"/>
              <a:ext cx="8290080" cy="621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4" descr="A picture containing text, broccoli&#10;&#10;Description automatically generated"/>
            <p:cNvPicPr/>
            <p:nvPr/>
          </p:nvPicPr>
          <p:blipFill>
            <a:blip r:embed="rId5"/>
            <a:stretch/>
          </p:blipFill>
          <p:spPr>
            <a:xfrm>
              <a:off x="1594440" y="14022000"/>
              <a:ext cx="8290080" cy="621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6" descr="A picture containing broccoli, green, plant, vegetable&#10;&#10;Description automatically generated"/>
            <p:cNvPicPr/>
            <p:nvPr/>
          </p:nvPicPr>
          <p:blipFill>
            <a:blip r:embed="rId6"/>
            <a:stretch/>
          </p:blipFill>
          <p:spPr>
            <a:xfrm>
              <a:off x="10472040" y="7518960"/>
              <a:ext cx="8290080" cy="621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8" descr="A picture containing broccoli&#10;&#10;Description automatically generated"/>
            <p:cNvPicPr/>
            <p:nvPr/>
          </p:nvPicPr>
          <p:blipFill>
            <a:blip r:embed="rId7"/>
            <a:stretch/>
          </p:blipFill>
          <p:spPr>
            <a:xfrm>
              <a:off x="10472040" y="14022000"/>
              <a:ext cx="8290080" cy="621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0" descr="A picture containing plant&#10;&#10;Description automatically generated"/>
            <p:cNvPicPr/>
            <p:nvPr/>
          </p:nvPicPr>
          <p:blipFill>
            <a:blip r:embed="rId8"/>
            <a:stretch/>
          </p:blipFill>
          <p:spPr>
            <a:xfrm>
              <a:off x="19278360" y="7493040"/>
              <a:ext cx="8290080" cy="621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12" descr="A picture containing night sky&#10;&#10;Description automatically generated"/>
            <p:cNvPicPr/>
            <p:nvPr/>
          </p:nvPicPr>
          <p:blipFill>
            <a:blip r:embed="rId9"/>
            <a:stretch/>
          </p:blipFill>
          <p:spPr>
            <a:xfrm>
              <a:off x="19256760" y="14039640"/>
              <a:ext cx="8290080" cy="6218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2"/>
            <p:cNvSpPr/>
            <p:nvPr/>
          </p:nvSpPr>
          <p:spPr>
            <a:xfrm>
              <a:off x="719280" y="7614000"/>
              <a:ext cx="1280160" cy="100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6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2"/>
            <p:cNvSpPr/>
            <p:nvPr/>
          </p:nvSpPr>
          <p:spPr>
            <a:xfrm>
              <a:off x="1678320" y="7566840"/>
              <a:ext cx="3757320" cy="100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0" spc="-1" strike="noStrike">
                  <a:solidFill>
                    <a:srgbClr val="00b050"/>
                  </a:solidFill>
                  <a:latin typeface="Arial"/>
                  <a:ea typeface="Arial"/>
                </a:rPr>
                <a:t>Oct3/4</a:t>
              </a:r>
              <a:endParaRPr b="0" lang="en-US" sz="6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2"/>
            <p:cNvSpPr/>
            <p:nvPr/>
          </p:nvSpPr>
          <p:spPr>
            <a:xfrm>
              <a:off x="1676880" y="14066640"/>
              <a:ext cx="6325200" cy="100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0" spc="-1" strike="noStrike">
                  <a:solidFill>
                    <a:srgbClr val="00b050"/>
                  </a:solidFill>
                  <a:latin typeface="Arial"/>
                  <a:ea typeface="Arial"/>
                </a:rPr>
                <a:t>Oct3/4 </a:t>
              </a:r>
              <a:r>
                <a:rPr b="1" lang="en-US" sz="6000" spc="-1" strike="noStrike">
                  <a:solidFill>
                    <a:srgbClr val="0000ff"/>
                  </a:solidFill>
                  <a:latin typeface="Arial"/>
                  <a:ea typeface="Arial"/>
                </a:rPr>
                <a:t>DAPI</a:t>
              </a:r>
              <a:endParaRPr b="0" lang="en-US" sz="6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9" name="Group 20"/>
          <p:cNvGrpSpPr/>
          <p:nvPr/>
        </p:nvGrpSpPr>
        <p:grpSpPr>
          <a:xfrm>
            <a:off x="676440" y="20524680"/>
            <a:ext cx="26892000" cy="6278760"/>
            <a:chOff x="676440" y="20524680"/>
            <a:chExt cx="26892000" cy="6278760"/>
          </a:xfrm>
        </p:grpSpPr>
        <p:pic>
          <p:nvPicPr>
            <p:cNvPr id="60" name="Picture 14" descr="A picture containing text, tree&#10;&#10;Description automatically generated"/>
            <p:cNvPicPr/>
            <p:nvPr/>
          </p:nvPicPr>
          <p:blipFill>
            <a:blip r:embed="rId10"/>
            <a:stretch/>
          </p:blipFill>
          <p:spPr>
            <a:xfrm>
              <a:off x="1594440" y="20524680"/>
              <a:ext cx="8290080" cy="621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16" descr="A screenshot of a computer&#10;&#10;Description automatically generated with medium confidence"/>
            <p:cNvPicPr/>
            <p:nvPr/>
          </p:nvPicPr>
          <p:blipFill>
            <a:blip r:embed="rId11"/>
            <a:stretch/>
          </p:blipFill>
          <p:spPr>
            <a:xfrm>
              <a:off x="10432080" y="20572560"/>
              <a:ext cx="8290080" cy="6217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18" descr="A screenshot of a computer&#10;&#10;Description automatically generated with low confidence"/>
            <p:cNvPicPr/>
            <p:nvPr/>
          </p:nvPicPr>
          <p:blipFill>
            <a:blip r:embed="rId12"/>
            <a:stretch/>
          </p:blipFill>
          <p:spPr>
            <a:xfrm>
              <a:off x="19278360" y="20585520"/>
              <a:ext cx="8290080" cy="6217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2"/>
            <p:cNvSpPr/>
            <p:nvPr/>
          </p:nvSpPr>
          <p:spPr>
            <a:xfrm>
              <a:off x="1657080" y="20572560"/>
              <a:ext cx="6325200" cy="100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0" spc="-1" strike="noStrike">
                  <a:solidFill>
                    <a:srgbClr val="00b050"/>
                  </a:solidFill>
                  <a:latin typeface="Arial"/>
                  <a:ea typeface="Arial"/>
                </a:rPr>
                <a:t>TRA-1-60 </a:t>
              </a:r>
              <a:r>
                <a:rPr b="1" lang="en-US" sz="6000" spc="-1" strike="noStrike">
                  <a:solidFill>
                    <a:srgbClr val="0000ff"/>
                  </a:solidFill>
                  <a:latin typeface="Arial"/>
                  <a:ea typeface="Arial"/>
                </a:rPr>
                <a:t>DAPI</a:t>
              </a:r>
              <a:endParaRPr b="0" lang="en-US" sz="6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2"/>
            <p:cNvSpPr/>
            <p:nvPr/>
          </p:nvSpPr>
          <p:spPr>
            <a:xfrm>
              <a:off x="676440" y="20572560"/>
              <a:ext cx="1280160" cy="100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6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5" name="TextBox 1"/>
          <p:cNvSpPr/>
          <p:nvPr/>
        </p:nvSpPr>
        <p:spPr>
          <a:xfrm>
            <a:off x="1593720" y="27144720"/>
            <a:ext cx="25954200" cy="143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Figure S1: Characterization of hiPSCs. (A) 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Representative images of hiPSC colony. </a:t>
            </a:r>
            <a:r>
              <a:rPr b="1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 Oct3/4 protein expression in hiPSCs. </a:t>
            </a:r>
            <a:r>
              <a:rPr b="1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(C) 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TRA-1-60 protein expression in hiPSCs.  Bar=200 </a:t>
            </a:r>
            <a:r>
              <a:rPr b="0" lang="el-GR" sz="44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m. 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Group 2"/>
          <p:cNvGrpSpPr/>
          <p:nvPr/>
        </p:nvGrpSpPr>
        <p:grpSpPr>
          <a:xfrm>
            <a:off x="1130400" y="3892680"/>
            <a:ext cx="26397000" cy="7157880"/>
            <a:chOff x="1130400" y="3892680"/>
            <a:chExt cx="26397000" cy="7157880"/>
          </a:xfrm>
        </p:grpSpPr>
        <p:graphicFrame>
          <p:nvGraphicFramePr>
            <p:cNvPr id="67" name="Object 1"/>
            <p:cNvGraphicFramePr/>
            <p:nvPr/>
          </p:nvGraphicFramePr>
          <p:xfrm>
            <a:off x="1901160" y="4829400"/>
            <a:ext cx="8274240" cy="62211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68" name="Object 1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901160" y="4829400"/>
                      <a:ext cx="8274240" cy="6221160"/>
                    </a:xfrm>
                    <a:prstGeom prst="rect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69" name="Object 2"/>
            <p:cNvGraphicFramePr/>
            <p:nvPr/>
          </p:nvGraphicFramePr>
          <p:xfrm>
            <a:off x="10802520" y="4783320"/>
            <a:ext cx="8079120" cy="62481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70" name="Object 2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0802520" y="4783320"/>
                      <a:ext cx="8079120" cy="6248160"/>
                    </a:xfrm>
                    <a:prstGeom prst="rect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71" name="Object 3"/>
            <p:cNvGraphicFramePr/>
            <p:nvPr/>
          </p:nvGraphicFramePr>
          <p:xfrm>
            <a:off x="19448280" y="4799160"/>
            <a:ext cx="8079120" cy="622440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72" name="Object 3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19448280" y="4799160"/>
                      <a:ext cx="8079120" cy="6224400"/>
                    </a:xfrm>
                    <a:prstGeom prst="rect">
                      <a:avLst/>
                    </a:prstGeom>
                    <a:ln w="255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73" name="TextBox 4"/>
            <p:cNvSpPr/>
            <p:nvPr/>
          </p:nvSpPr>
          <p:spPr>
            <a:xfrm>
              <a:off x="4323600" y="3996360"/>
              <a:ext cx="3276720" cy="82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1C1iPSC</a:t>
              </a:r>
              <a:endParaRPr b="0" lang="en-US" sz="4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5"/>
            <p:cNvSpPr/>
            <p:nvPr/>
          </p:nvSpPr>
          <p:spPr>
            <a:xfrm>
              <a:off x="12855960" y="3904200"/>
              <a:ext cx="4633920" cy="82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P2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等线"/>
                </a:rPr>
                <a:t>-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C8iPSCs</a:t>
              </a:r>
              <a:endParaRPr b="0" lang="en-US" sz="4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6"/>
            <p:cNvSpPr/>
            <p:nvPr/>
          </p:nvSpPr>
          <p:spPr>
            <a:xfrm>
              <a:off x="21817800" y="3892680"/>
              <a:ext cx="4961880" cy="825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P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等线"/>
                </a:rPr>
                <a:t>3-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C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等线"/>
                </a:rPr>
                <a:t>6</a:t>
              </a:r>
              <a:r>
                <a:rPr b="1" lang="en-US" sz="48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iPSCs</a:t>
              </a:r>
              <a:endParaRPr b="0" lang="en-US" sz="4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29"/>
            <p:cNvSpPr/>
            <p:nvPr/>
          </p:nvSpPr>
          <p:spPr>
            <a:xfrm>
              <a:off x="1130400" y="4768560"/>
              <a:ext cx="626040" cy="100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6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7" name="Group 6"/>
          <p:cNvGrpSpPr/>
          <p:nvPr/>
        </p:nvGrpSpPr>
        <p:grpSpPr>
          <a:xfrm>
            <a:off x="1090440" y="11201400"/>
            <a:ext cx="26497080" cy="12773160"/>
            <a:chOff x="1090440" y="11201400"/>
            <a:chExt cx="26497080" cy="12773160"/>
          </a:xfrm>
        </p:grpSpPr>
        <p:grpSp>
          <p:nvGrpSpPr>
            <p:cNvPr id="78" name="Group 4"/>
            <p:cNvGrpSpPr/>
            <p:nvPr/>
          </p:nvGrpSpPr>
          <p:grpSpPr>
            <a:xfrm>
              <a:off x="10771200" y="17768520"/>
              <a:ext cx="16783560" cy="6206040"/>
              <a:chOff x="10771200" y="17768520"/>
              <a:chExt cx="16783560" cy="6206040"/>
            </a:xfrm>
          </p:grpSpPr>
          <p:pic>
            <p:nvPicPr>
              <p:cNvPr id="79" name="Picture 6" descr="A picture containing clothing, fabric&#10;&#10;Description automatically generated"/>
              <p:cNvPicPr/>
              <p:nvPr/>
            </p:nvPicPr>
            <p:blipFill>
              <a:blip r:embed="rId7"/>
              <a:stretch/>
            </p:blipFill>
            <p:spPr>
              <a:xfrm>
                <a:off x="10771200" y="17768520"/>
                <a:ext cx="8274240" cy="6206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0" name="Picture 10" descr="A picture containing clothing&#10;&#10;Description automatically generated"/>
              <p:cNvPicPr/>
              <p:nvPr/>
            </p:nvPicPr>
            <p:blipFill>
              <a:blip r:embed="rId8"/>
              <a:stretch/>
            </p:blipFill>
            <p:spPr>
              <a:xfrm>
                <a:off x="19485360" y="17768520"/>
                <a:ext cx="8069400" cy="6104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1" name="TextBox 19"/>
              <p:cNvSpPr/>
              <p:nvPr/>
            </p:nvSpPr>
            <p:spPr>
              <a:xfrm>
                <a:off x="13836600" y="18829080"/>
                <a:ext cx="985680" cy="82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4800" spc="-1" strike="noStrike">
                    <a:solidFill>
                      <a:srgbClr val="000000"/>
                    </a:solidFill>
                    <a:latin typeface="Arial"/>
                    <a:ea typeface="等线"/>
                  </a:rPr>
                  <a:t>*</a:t>
                </a:r>
                <a:endParaRPr b="0" lang="en-US" sz="4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TextBox 20"/>
              <p:cNvSpPr/>
              <p:nvPr/>
            </p:nvSpPr>
            <p:spPr>
              <a:xfrm>
                <a:off x="23860800" y="19748160"/>
                <a:ext cx="984240" cy="82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4800" spc="-1" strike="noStrike">
                    <a:solidFill>
                      <a:srgbClr val="000000"/>
                    </a:solidFill>
                    <a:latin typeface="Arial"/>
                    <a:ea typeface="等线"/>
                  </a:rPr>
                  <a:t>*</a:t>
                </a:r>
                <a:endParaRPr b="0" lang="en-US" sz="4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TextBox 32"/>
              <p:cNvSpPr/>
              <p:nvPr/>
            </p:nvSpPr>
            <p:spPr>
              <a:xfrm>
                <a:off x="20269440" y="19191240"/>
                <a:ext cx="417960" cy="82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4800" spc="-1" strike="noStrike">
                    <a:solidFill>
                      <a:srgbClr val="000000"/>
                    </a:solidFill>
                    <a:latin typeface="Arial"/>
                    <a:ea typeface="等线"/>
                  </a:rPr>
                  <a:t>#</a:t>
                </a:r>
                <a:endParaRPr b="0" lang="en-US" sz="4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TextBox 32"/>
              <p:cNvSpPr/>
              <p:nvPr/>
            </p:nvSpPr>
            <p:spPr>
              <a:xfrm>
                <a:off x="16994520" y="19578240"/>
                <a:ext cx="527040" cy="703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4000" spc="-1" strike="noStrike">
                    <a:solidFill>
                      <a:srgbClr val="000000"/>
                    </a:solidFill>
                    <a:latin typeface="Arial"/>
                    <a:ea typeface="等线"/>
                  </a:rPr>
                  <a:t>#</a:t>
                </a:r>
                <a:endParaRPr b="0" lang="en-US" sz="4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5" name="Group 5"/>
            <p:cNvGrpSpPr/>
            <p:nvPr/>
          </p:nvGrpSpPr>
          <p:grpSpPr>
            <a:xfrm>
              <a:off x="1090440" y="11201400"/>
              <a:ext cx="26497080" cy="6332760"/>
              <a:chOff x="1090440" y="11201400"/>
              <a:chExt cx="26497080" cy="6332760"/>
            </a:xfrm>
          </p:grpSpPr>
          <p:pic>
            <p:nvPicPr>
              <p:cNvPr id="86" name="Picture 2" descr="A picture containing purple&#10;&#10;Description automatically generated"/>
              <p:cNvPicPr/>
              <p:nvPr/>
            </p:nvPicPr>
            <p:blipFill>
              <a:blip r:embed="rId9"/>
              <a:stretch/>
            </p:blipFill>
            <p:spPr>
              <a:xfrm>
                <a:off x="1902240" y="11312280"/>
                <a:ext cx="8274240" cy="6221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7" name="Picture 4" descr="A picture containing purple, vegetable&#10;&#10;Description automatically generated"/>
              <p:cNvPicPr/>
              <p:nvPr/>
            </p:nvPicPr>
            <p:blipFill>
              <a:blip r:embed="rId10"/>
              <a:stretch/>
            </p:blipFill>
            <p:spPr>
              <a:xfrm>
                <a:off x="10803960" y="11312280"/>
                <a:ext cx="8274240" cy="6206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8" name="Picture 8" descr=""/>
              <p:cNvPicPr/>
              <p:nvPr/>
            </p:nvPicPr>
            <p:blipFill>
              <a:blip r:embed="rId11"/>
              <a:stretch/>
            </p:blipFill>
            <p:spPr>
              <a:xfrm>
                <a:off x="19449720" y="11312280"/>
                <a:ext cx="8137800" cy="6127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9" name="TextBox 18"/>
              <p:cNvSpPr/>
              <p:nvPr/>
            </p:nvSpPr>
            <p:spPr>
              <a:xfrm>
                <a:off x="3505680" y="15214680"/>
                <a:ext cx="984240" cy="91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5400" spc="-1" strike="noStrike">
                    <a:solidFill>
                      <a:srgbClr val="000000"/>
                    </a:solidFill>
                    <a:latin typeface="Arial"/>
                    <a:ea typeface="等线"/>
                  </a:rPr>
                  <a:t>*</a:t>
                </a:r>
                <a:endParaRPr b="0" lang="en-US" sz="5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90" name="Straight Arrow Connector 22"/>
              <p:cNvCxnSpPr/>
              <p:nvPr/>
            </p:nvCxnSpPr>
            <p:spPr>
              <a:xfrm flipV="1">
                <a:off x="16232040" y="14833080"/>
                <a:ext cx="457920" cy="11520"/>
              </a:xfrm>
              <a:prstGeom prst="straightConnector1">
                <a:avLst/>
              </a:prstGeom>
              <a:ln w="6336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91" name="Straight Arrow Connector 23"/>
              <p:cNvCxnSpPr/>
              <p:nvPr/>
            </p:nvCxnSpPr>
            <p:spPr>
              <a:xfrm flipV="1">
                <a:off x="21926520" y="13461480"/>
                <a:ext cx="459360" cy="11520"/>
              </a:xfrm>
              <a:prstGeom prst="straightConnector1">
                <a:avLst/>
              </a:prstGeom>
              <a:ln w="6336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92" name="Straight Arrow Connector 24"/>
              <p:cNvCxnSpPr/>
              <p:nvPr/>
            </p:nvCxnSpPr>
            <p:spPr>
              <a:xfrm flipH="1">
                <a:off x="2747160" y="14037840"/>
                <a:ext cx="343440" cy="495720"/>
              </a:xfrm>
              <a:prstGeom prst="straightConnector1">
                <a:avLst/>
              </a:prstGeom>
              <a:ln w="63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93" name="TextBox 30"/>
              <p:cNvSpPr/>
              <p:nvPr/>
            </p:nvSpPr>
            <p:spPr>
              <a:xfrm>
                <a:off x="9449640" y="15281280"/>
                <a:ext cx="527040" cy="82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4800" spc="-1" strike="noStrike">
                    <a:solidFill>
                      <a:srgbClr val="000000"/>
                    </a:solidFill>
                    <a:latin typeface="Arial"/>
                    <a:ea typeface="等线"/>
                  </a:rPr>
                  <a:t>#</a:t>
                </a:r>
                <a:endParaRPr b="0" lang="en-US" sz="4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Box 31"/>
              <p:cNvSpPr/>
              <p:nvPr/>
            </p:nvSpPr>
            <p:spPr>
              <a:xfrm>
                <a:off x="14020200" y="14411520"/>
                <a:ext cx="528480" cy="82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4800" spc="-1" strike="noStrike">
                    <a:solidFill>
                      <a:srgbClr val="000000"/>
                    </a:solidFill>
                    <a:latin typeface="Arial"/>
                    <a:ea typeface="等线"/>
                  </a:rPr>
                  <a:t>#</a:t>
                </a:r>
                <a:endParaRPr b="0" lang="en-US" sz="4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TextBox 32"/>
              <p:cNvSpPr/>
              <p:nvPr/>
            </p:nvSpPr>
            <p:spPr>
              <a:xfrm>
                <a:off x="20041920" y="13004640"/>
                <a:ext cx="527040" cy="825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4800" spc="-1" strike="noStrike">
                    <a:solidFill>
                      <a:srgbClr val="000000"/>
                    </a:solidFill>
                    <a:latin typeface="Arial"/>
                    <a:ea typeface="等线"/>
                  </a:rPr>
                  <a:t>#</a:t>
                </a:r>
                <a:endParaRPr b="0" lang="en-US" sz="4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96" name="Straight Arrow Connector 25"/>
              <p:cNvCxnSpPr/>
              <p:nvPr/>
            </p:nvCxnSpPr>
            <p:spPr>
              <a:xfrm>
                <a:off x="21973680" y="11312280"/>
                <a:ext cx="1080" cy="397440"/>
              </a:xfrm>
              <a:prstGeom prst="straightConnector1">
                <a:avLst/>
              </a:prstGeom>
              <a:ln w="63360">
                <a:solidFill>
                  <a:srgbClr val="000000"/>
                </a:solidFill>
                <a:miter/>
                <a:tailEnd len="med" type="arrow" w="med"/>
              </a:ln>
            </p:spPr>
          </p:cxnSp>
          <p:cxnSp>
            <p:nvCxnSpPr>
              <p:cNvPr id="97" name="Straight Arrow Connector 27"/>
              <p:cNvCxnSpPr/>
              <p:nvPr/>
            </p:nvCxnSpPr>
            <p:spPr>
              <a:xfrm>
                <a:off x="22480200" y="14571720"/>
                <a:ext cx="1080" cy="491040"/>
              </a:xfrm>
              <a:prstGeom prst="straightConnector1">
                <a:avLst/>
              </a:prstGeom>
              <a:ln w="633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98" name="TextBox 30"/>
              <p:cNvSpPr/>
              <p:nvPr/>
            </p:nvSpPr>
            <p:spPr>
              <a:xfrm>
                <a:off x="1090440" y="11201400"/>
                <a:ext cx="626040" cy="100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6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</a:t>
                </a:r>
                <a:endParaRPr b="0" lang="en-US" sz="6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99" name="Group 1"/>
          <p:cNvGrpSpPr/>
          <p:nvPr/>
        </p:nvGrpSpPr>
        <p:grpSpPr>
          <a:xfrm>
            <a:off x="2117880" y="24755400"/>
            <a:ext cx="25218720" cy="2104920"/>
            <a:chOff x="2117880" y="24755400"/>
            <a:chExt cx="25218720" cy="2104920"/>
          </a:xfrm>
        </p:grpSpPr>
        <p:sp>
          <p:nvSpPr>
            <p:cNvPr id="100" name="TextBox 38"/>
            <p:cNvSpPr/>
            <p:nvPr/>
          </p:nvSpPr>
          <p:spPr>
            <a:xfrm>
              <a:off x="2117880" y="24755400"/>
              <a:ext cx="25218720" cy="21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4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gure S2: Karyotyping and teratoma analysis of hiPSCs. (A) 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Arial"/>
                </a:rPr>
                <a:t>Karyotyping of P1C1iPSCs, 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P2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等线"/>
                </a:rPr>
                <a:t>-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C8iPSCs, and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等线"/>
                </a:rPr>
                <a:t> 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P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等线"/>
                </a:rPr>
                <a:t>3-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C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等线"/>
                </a:rPr>
                <a:t>6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iPSCs. </a:t>
              </a:r>
              <a:r>
                <a:rPr b="1" lang="en-US" sz="44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(B)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H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等线"/>
                </a:rPr>
                <a:t>ematoxylin and eosin stained teratoma section for identification of cartilage (</a:t>
              </a:r>
              <a:r>
                <a:rPr b="1" lang="en-US" sz="4400" spc="-1" strike="noStrike">
                  <a:solidFill>
                    <a:srgbClr val="000000"/>
                  </a:solidFill>
                  <a:latin typeface="Arial"/>
                  <a:ea typeface="等线"/>
                </a:rPr>
                <a:t>* </a:t>
              </a:r>
              <a:r>
                <a:rPr b="0" lang="en-US" sz="4400" spc="-1" strike="noStrike">
                  <a:solidFill>
                    <a:srgbClr val="000000"/>
                  </a:solidFill>
                  <a:latin typeface="Arial"/>
                  <a:ea typeface="等线"/>
                </a:rPr>
                <a:t>mesoderm), e</a:t>
              </a:r>
              <a:r>
                <a:rPr b="0" lang="en-US" sz="4400" spc="-1" strike="noStrike">
                  <a:solidFill>
                    <a:srgbClr val="202122"/>
                  </a:solidFill>
                  <a:latin typeface="Arial"/>
                  <a:ea typeface="等线"/>
                </a:rPr>
                <a:t>pidermis (    ectoderm), and gastrointestinal glands (</a:t>
              </a:r>
              <a:r>
                <a:rPr b="1" lang="en-US" sz="4400" spc="-1" strike="noStrike">
                  <a:solidFill>
                    <a:srgbClr val="000000"/>
                  </a:solidFill>
                  <a:latin typeface="Arial"/>
                  <a:ea typeface="等线"/>
                </a:rPr>
                <a:t>#</a:t>
              </a:r>
              <a:r>
                <a:rPr b="0" lang="en-US" sz="4400" spc="-1" strike="noStrike">
                  <a:solidFill>
                    <a:srgbClr val="202122"/>
                  </a:solidFill>
                  <a:latin typeface="Arial"/>
                  <a:ea typeface="等线"/>
                </a:rPr>
                <a:t>  endoderm). </a:t>
              </a:r>
              <a:endParaRPr b="0" lang="en-US" sz="4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01" name="Straight Arrow Connector 39"/>
            <p:cNvCxnSpPr/>
            <p:nvPr/>
          </p:nvCxnSpPr>
          <p:spPr>
            <a:xfrm flipV="1">
              <a:off x="11625120" y="26444160"/>
              <a:ext cx="457920" cy="11520"/>
            </a:xfrm>
            <a:prstGeom prst="straightConnector1">
              <a:avLst/>
            </a:prstGeom>
            <a:ln w="6336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" name=""/>
          <p:cNvGraphicFramePr/>
          <p:nvPr/>
        </p:nvGraphicFramePr>
        <p:xfrm>
          <a:off x="3073320" y="8940960"/>
          <a:ext cx="22479120" cy="11629800"/>
        </p:xfrm>
        <a:graphic>
          <a:graphicData uri="http://schemas.openxmlformats.org/drawingml/2006/table">
            <a:tbl>
              <a:tblPr/>
              <a:tblGrid>
                <a:gridCol w="3540240"/>
                <a:gridCol w="5143320"/>
                <a:gridCol w="1703520"/>
                <a:gridCol w="4175280"/>
                <a:gridCol w="6313320"/>
                <a:gridCol w="1603440"/>
              </a:tblGrid>
              <a:tr h="685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ary antibody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tegory number 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lution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condary antibody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tegory number 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lution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PDH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T-2118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rabbit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T-7074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-eNOS(Ser 1177)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293032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NOS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37675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ndothelin-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517436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5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CAM-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T-67836S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rabbit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T-7074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CAM-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T-39036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rabbit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T-7074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9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MP-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vitrogen-PA5-16498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rabbit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T-7074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yR</a:t>
                      </a:r>
                      <a:r>
                        <a:rPr b="0" lang="el-GR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α2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398964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yR</a:t>
                      </a:r>
                      <a:r>
                        <a:rPr b="0" lang="el-GR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β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365819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yT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hermo Fisher: BS-11604R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rabbit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T-7074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yT2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39009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5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SHMT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365203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5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678040"/>
                          <a:tab algn="l" pos="5356080"/>
                          <a:tab algn="l" pos="8034480"/>
                          <a:tab algn="l" pos="1071252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SHMT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39064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678040"/>
                          <a:tab algn="l" pos="5356080"/>
                          <a:tab algn="l" pos="8034480"/>
                          <a:tab algn="l" pos="1071252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678040"/>
                          <a:tab algn="l" pos="5356080"/>
                          <a:tab algn="l" pos="8034480"/>
                          <a:tab algn="l" pos="1071252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270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16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5633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5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2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6246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9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53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126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1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9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P5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11041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fn-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166644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93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fn-2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10056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5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4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is-1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-376469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5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oatxmouse IgG HRP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kin Elmer-cat-NEF 812001 EA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0" lang="en-US" sz="3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:2000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03" name="TextBox 4"/>
          <p:cNvSpPr/>
          <p:nvPr/>
        </p:nvSpPr>
        <p:spPr>
          <a:xfrm>
            <a:off x="10731600" y="7978680"/>
            <a:ext cx="1338876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Table S1. Antibody information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traight Connector 6"/>
          <p:cNvSpPr/>
          <p:nvPr/>
        </p:nvSpPr>
        <p:spPr>
          <a:xfrm flipV="1">
            <a:off x="3073320" y="8894880"/>
            <a:ext cx="22136040" cy="46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Straight Connector 7"/>
          <p:cNvSpPr/>
          <p:nvPr/>
        </p:nvSpPr>
        <p:spPr>
          <a:xfrm flipV="1">
            <a:off x="3073320" y="20793240"/>
            <a:ext cx="22136040" cy="47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6" name=""/>
          <p:cNvGraphicFramePr/>
          <p:nvPr/>
        </p:nvGraphicFramePr>
        <p:xfrm>
          <a:off x="8369280" y="6539040"/>
          <a:ext cx="13335120" cy="17898840"/>
        </p:xfrm>
        <a:graphic>
          <a:graphicData uri="http://schemas.openxmlformats.org/drawingml/2006/table">
            <a:tbl>
              <a:tblPr/>
              <a:tblGrid>
                <a:gridCol w="2933640"/>
                <a:gridCol w="2933640"/>
                <a:gridCol w="2651400"/>
                <a:gridCol w="2273040"/>
                <a:gridCol w="2543400"/>
              </a:tblGrid>
              <a:tr h="110448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CBC-EC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1C1-EC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P2-EC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P3-EC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G-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.15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0.8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8248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ngiostatin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09.2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XCL1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02.99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4.3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9.98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1.7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GF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.0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9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.1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.24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GF-4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36.1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llistatin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55.6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-CSF 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M-CSF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-309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3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L-1b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78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6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44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L-4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L-1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0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5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8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L-12p4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.5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7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3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L-12p7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3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5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08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-TAC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1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3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65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8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CP-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2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94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2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CP-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7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.08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48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.6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CP-4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.55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1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5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636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MP-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7.89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84.9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446.0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35.5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MP-9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82.2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48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56.1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818.24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CAM-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1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35.2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6.1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Fa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8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Fb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9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ie-1*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85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ie-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5.1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PAR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28.3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8.74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57.7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24.6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EGF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3.0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.5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85.7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8.0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EGF R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19.38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.36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5.99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1.8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EGF R3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.71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27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8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555840"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EGF-D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.9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.12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.3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2860560"/>
                          <a:tab algn="l" pos="5721480"/>
                          <a:tab algn="l" pos="8582040"/>
                        </a:tabLst>
                      </a:pPr>
                      <a:r>
                        <a:rPr b="1" lang="en-US" sz="3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.20</a:t>
                      </a:r>
                      <a:endParaRPr b="0" lang="en-US" sz="3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40" marR="68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07" name="Straight Connector 8"/>
          <p:cNvSpPr/>
          <p:nvPr/>
        </p:nvSpPr>
        <p:spPr>
          <a:xfrm>
            <a:off x="8721720" y="24504480"/>
            <a:ext cx="129826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Straight Connector 9"/>
          <p:cNvSpPr/>
          <p:nvPr/>
        </p:nvSpPr>
        <p:spPr>
          <a:xfrm>
            <a:off x="8721720" y="7224840"/>
            <a:ext cx="129826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1"/>
          <p:cNvSpPr/>
          <p:nvPr/>
        </p:nvSpPr>
        <p:spPr>
          <a:xfrm>
            <a:off x="7721640" y="5489640"/>
            <a:ext cx="1500804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Arial"/>
                <a:ea typeface="Arial"/>
              </a:rPr>
              <a:t>Table S2.  Paracrine factors released from hiPSC-EC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2-02-19T02:32:12Z</dcterms:created>
  <dc:creator>NUS</dc:creator>
  <dc:description/>
  <dc:language>en-US</dc:language>
  <cp:lastModifiedBy>Ye Lei</cp:lastModifiedBy>
  <dcterms:modified xsi:type="dcterms:W3CDTF">2021-03-26T04:36:56Z</dcterms:modified>
  <cp:revision>1685</cp:revision>
  <dc:subject/>
  <dc:title>Human VEGF Transduced Human Skeletal Myoblast cell: in vitro Study</dc:title>
</cp:coreProperties>
</file>